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 varScale="1">
        <p:scale>
          <a:sx n="71" d="100"/>
          <a:sy n="71" d="100"/>
        </p:scale>
        <p:origin x="40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362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701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2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41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80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568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2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1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569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161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84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814" t="2015" r="2601" b="26400"/>
          <a:stretch/>
        </p:blipFill>
        <p:spPr>
          <a:xfrm>
            <a:off x="3865336" y="3827196"/>
            <a:ext cx="4440465" cy="198193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93921" y="5769844"/>
            <a:ext cx="737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3K9u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03875" y="5769844"/>
            <a:ext cx="5677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3K9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me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665651" y="5769844"/>
            <a:ext cx="5677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3K9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me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321514" y="5769844"/>
            <a:ext cx="5677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3K9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me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521159" y="5769844"/>
            <a:ext cx="840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3K9K14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ac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821165" y="5769844"/>
            <a:ext cx="840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3K9K14</a:t>
            </a:r>
            <a:endParaRPr lang="en-US" sz="1200" baseline="-25000" dirty="0">
              <a:solidFill>
                <a:prstClr val="black"/>
              </a:solidFill>
              <a:latin typeface="Arial"/>
              <a:cs typeface="Arial"/>
            </a:endParaRPr>
          </a:p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ac1</a:t>
            </a:r>
            <a:endParaRPr lang="en-US" sz="1200" baseline="-25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325898" y="362062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prstClr val="black"/>
                </a:solidFill>
                <a:latin typeface="Arial"/>
                <a:cs typeface="Arial"/>
              </a:rPr>
              <a:t>B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7120670" y="3661860"/>
            <a:ext cx="1053068" cy="707193"/>
            <a:chOff x="7654414" y="72470"/>
            <a:chExt cx="1053068" cy="707193"/>
          </a:xfrm>
        </p:grpSpPr>
        <p:sp>
          <p:nvSpPr>
            <p:cNvPr id="11" name="Rectangle 10"/>
            <p:cNvSpPr>
              <a:spLocks noChangeAspect="1"/>
            </p:cNvSpPr>
            <p:nvPr/>
          </p:nvSpPr>
          <p:spPr>
            <a:xfrm>
              <a:off x="7654414" y="129334"/>
              <a:ext cx="183615" cy="1814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12" name="Rectangle 11"/>
            <p:cNvSpPr>
              <a:spLocks noChangeAspect="1"/>
            </p:cNvSpPr>
            <p:nvPr/>
          </p:nvSpPr>
          <p:spPr>
            <a:xfrm>
              <a:off x="7654414" y="560736"/>
              <a:ext cx="183615" cy="181400"/>
            </a:xfrm>
            <a:prstGeom prst="rect">
              <a:avLst/>
            </a:prstGeom>
            <a:solidFill>
              <a:srgbClr val="0070C0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13" name="Rectangle 12"/>
            <p:cNvSpPr>
              <a:spLocks noChangeAspect="1"/>
            </p:cNvSpPr>
            <p:nvPr/>
          </p:nvSpPr>
          <p:spPr>
            <a:xfrm>
              <a:off x="7654414" y="345035"/>
              <a:ext cx="183615" cy="181400"/>
            </a:xfrm>
            <a:prstGeom prst="rect">
              <a:avLst/>
            </a:prstGeom>
            <a:solidFill>
              <a:srgbClr val="002060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791847" y="72470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Arial"/>
                  <a:cs typeface="Arial"/>
                </a:rPr>
                <a:t>= S2 rep 2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791847" y="289724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Arial"/>
                  <a:cs typeface="Arial"/>
                </a:rPr>
                <a:t>= G3 rep 2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791847" y="502664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Arial"/>
                  <a:cs typeface="Arial"/>
                </a:rPr>
                <a:t>= B2 rep 2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5367914" y="6207906"/>
            <a:ext cx="1647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istone Modifications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/>
          <a:srcRect l="1769" t="2807" r="1878" b="7651"/>
          <a:stretch/>
        </p:blipFill>
        <p:spPr>
          <a:xfrm>
            <a:off x="3838231" y="264083"/>
            <a:ext cx="4429761" cy="247904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4399800" y="2646209"/>
            <a:ext cx="627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4ac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422323" y="2646209"/>
            <a:ext cx="627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4ac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401912" y="2646209"/>
            <a:ext cx="627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4ac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351114" y="2646209"/>
            <a:ext cx="627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4ac4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6848614" y="680179"/>
            <a:ext cx="1053068" cy="707193"/>
            <a:chOff x="7654414" y="72470"/>
            <a:chExt cx="1053068" cy="707193"/>
          </a:xfrm>
        </p:grpSpPr>
        <p:sp>
          <p:nvSpPr>
            <p:cNvPr id="24" name="Rectangle 23"/>
            <p:cNvSpPr>
              <a:spLocks noChangeAspect="1"/>
            </p:cNvSpPr>
            <p:nvPr/>
          </p:nvSpPr>
          <p:spPr>
            <a:xfrm>
              <a:off x="7654414" y="129334"/>
              <a:ext cx="183615" cy="1814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25" name="Rectangle 24"/>
            <p:cNvSpPr>
              <a:spLocks noChangeAspect="1"/>
            </p:cNvSpPr>
            <p:nvPr/>
          </p:nvSpPr>
          <p:spPr>
            <a:xfrm>
              <a:off x="7654414" y="560736"/>
              <a:ext cx="183615" cy="181400"/>
            </a:xfrm>
            <a:prstGeom prst="rect">
              <a:avLst/>
            </a:prstGeom>
            <a:solidFill>
              <a:srgbClr val="0070C0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26" name="Rectangle 25"/>
            <p:cNvSpPr>
              <a:spLocks noChangeAspect="1"/>
            </p:cNvSpPr>
            <p:nvPr/>
          </p:nvSpPr>
          <p:spPr>
            <a:xfrm>
              <a:off x="7654414" y="345035"/>
              <a:ext cx="183615" cy="181400"/>
            </a:xfrm>
            <a:prstGeom prst="rect">
              <a:avLst/>
            </a:prstGeom>
            <a:solidFill>
              <a:srgbClr val="002060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791847" y="72470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Arial"/>
                  <a:cs typeface="Arial"/>
                </a:rPr>
                <a:t>= S2 rep 2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791847" y="289724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Arial"/>
                  <a:cs typeface="Arial"/>
                </a:rPr>
                <a:t>= G3 rep 2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791847" y="502664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Arial"/>
                  <a:cs typeface="Arial"/>
                </a:rPr>
                <a:t>= B2 rep 2</a:t>
              </a: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3325898" y="30369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prstClr val="black"/>
                </a:solidFill>
                <a:latin typeface="Arial"/>
                <a:cs typeface="Arial"/>
              </a:rPr>
              <a:t>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517095" y="2862830"/>
            <a:ext cx="1647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istone Modification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31070" y="6450568"/>
            <a:ext cx="10729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Figure S1: Replicate analysis of histone post-translational modifications from bulk histones in </a:t>
            </a:r>
            <a:r>
              <a:rPr lang="en-US" dirty="0" err="1">
                <a:solidFill>
                  <a:prstClr val="black"/>
                </a:solidFill>
              </a:rPr>
              <a:t>upSET</a:t>
            </a:r>
            <a:r>
              <a:rPr lang="en-US" dirty="0">
                <a:solidFill>
                  <a:prstClr val="black"/>
                </a:solidFill>
              </a:rPr>
              <a:t> mutant cells 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2770708" y="1372678"/>
            <a:ext cx="15450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Relative abundance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2882766" y="4671691"/>
            <a:ext cx="15450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Relative abundance</a:t>
            </a:r>
          </a:p>
        </p:txBody>
      </p:sp>
    </p:spTree>
    <p:extLst>
      <p:ext uri="{BB962C8B-B14F-4D97-AF65-F5344CB8AC3E}">
        <p14:creationId xmlns:p14="http://schemas.microsoft.com/office/powerpoint/2010/main" val="856099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yles</dc:creator>
  <cp:lastModifiedBy>mlyles</cp:lastModifiedBy>
  <cp:revision>1</cp:revision>
  <dcterms:created xsi:type="dcterms:W3CDTF">2016-12-27T20:26:56Z</dcterms:created>
  <dcterms:modified xsi:type="dcterms:W3CDTF">2016-12-27T20:27:08Z</dcterms:modified>
</cp:coreProperties>
</file>